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4" d="100"/>
          <a:sy n="84" d="100"/>
        </p:scale>
        <p:origin x="643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BB48C5-07FE-9D1B-370D-2994CC3769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D382EE0-9A39-9468-7F85-3DF5E95FBB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CEDFED-436D-DC5C-EA81-E92236FE7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8F84EA-2596-DAE3-8648-B7651A64B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FD43CE-3BC3-934B-171A-C4F6F15AC2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474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1CEF19-B28D-A471-0F02-FE52D00DE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C77C68C-31A0-F342-80E3-CC9ECB5C5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87B4B5-C597-33A0-8E63-0359CF98B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A2F8FC-212E-CD5E-0159-35F043F96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CC3C35-F525-50B7-E869-5EBACC904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9958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BDDE29A-1894-5DD8-B4D7-0D996DF362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E8E31B6-9BF7-A381-BFEE-674E31AA2F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234DAAF-F817-19AE-0C3B-4348AA8AC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95EDD3-AF66-8062-58A6-B43EC80D1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F511BF-1053-D49C-0A63-308ED8C05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390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BE9BC5-7F38-FA4F-BCF1-7BC6354C11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7E7964-665D-24BA-6E96-5B6EF43EC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956F07-3FED-2146-1D46-D9FB41D15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D75CCF-5208-B43D-B2BF-41AF4BA3E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070C0C-1D55-796E-0026-32F768300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64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514400-9A97-00E2-24D5-DBF4ED449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F5D51F-7E6B-3DF2-1C0F-B7EDABB238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6C21161-D42C-5578-7213-2303E6311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4B6B51-15F7-C75A-6B6D-0E17CFD22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FF4D49-7107-4499-B18A-401D2BC13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8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57E8E6-72A5-11DB-3F31-848913F02D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E169EB-C58D-B1E5-43AB-BABA28CABE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5ACCFB8-B401-FE7A-8B82-7BE514E99D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5C23409-8F01-9746-D1FA-3895DC937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F0F0AE-D3E0-43F5-CC01-7E6EE53AD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BDE148-3969-EA7E-FE1D-B8E6D477C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439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34E97C-DAA6-B2E7-36FD-96ACFA0EA8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04F7B6-38F4-EA20-7DCD-D480FEEDD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9F65E31-1779-C152-C6F6-BFF6EF1A17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CAE218B-97AD-41A8-5C0F-0EDE5E9D45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BB6B5DC-C84B-217E-838B-60D60F2E7D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31343EB-9532-8B76-349A-4665E29B5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DBA62EE-C1E3-6B97-C026-82D0D1676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61899EF-8A4A-97D5-51FE-0501DE8AB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71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23D8DB-5024-D94D-01FC-2C19297DE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86BF58B-75BE-2937-F9E7-6A5961A1A0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447BBA3-57FE-774C-831D-A3275AFCC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5F1E156-D289-6BC5-6707-EBBC35D77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5872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1529CC0-EC8D-9E83-D077-FB7699F02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DBEF893-937B-BCEF-35FF-1B3370522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9742525-D29E-CE47-BE94-52C23BC6C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7649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765A9C-1393-8562-32BB-869A816BEA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24B142C-4B3D-7CBD-7353-34E60652A0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E68C0A0-7249-AFCC-80D3-199C35D537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219BA8-6FE5-69D0-DF88-80C03D3D3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6BC657-CF0B-3496-F4D7-CADB1E458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078901-3900-9B79-1C38-19786EFFE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3556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8605D9-32F2-E9EC-C6AB-1109738969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0B10755-227D-3F79-C3E0-DFAB2245B9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404D105-16E3-14F9-EC86-D35BCF64AA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53D2C1-814A-F34D-2703-0324D58832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9A5A43-00EE-1DF9-277B-744AE2DF3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ED33C32-8715-A405-65AD-B506AEF07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835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5EE57A3-4437-369B-5AFA-F27122E4B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05938D2-C398-098E-1F2C-BA0018C2F3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D3DE92-BEAA-77D3-73A0-89038A9651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56D56-CE82-44B4-8597-6B0E10E93974}" type="datetimeFigureOut">
              <a:rPr lang="zh-CN" altLang="en-US" smtClean="0"/>
              <a:t>2023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FECD39-6418-915B-9F10-4EA86C9B37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35A3205-820C-6E62-8B20-D7410699EB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7A3C1-4218-433A-BAFD-CF8BFF1C9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160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1992240" y="353354"/>
            <a:ext cx="9003307" cy="6172091"/>
            <a:chOff x="1148513" y="908317"/>
            <a:chExt cx="4364522" cy="2992037"/>
          </a:xfrm>
        </p:grpSpPr>
        <p:grpSp>
          <p:nvGrpSpPr>
            <p:cNvPr id="24" name="组合 23"/>
            <p:cNvGrpSpPr/>
            <p:nvPr/>
          </p:nvGrpSpPr>
          <p:grpSpPr>
            <a:xfrm>
              <a:off x="1148513" y="908317"/>
              <a:ext cx="4364522" cy="2992037"/>
              <a:chOff x="1148513" y="908317"/>
              <a:chExt cx="4364522" cy="2992037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74"/>
              <a:stretch>
                <a:fillRect/>
              </a:stretch>
            </p:blipFill>
            <p:spPr>
              <a:xfrm>
                <a:off x="1185234" y="936025"/>
                <a:ext cx="4293166" cy="2911277"/>
              </a:xfrm>
              <a:prstGeom prst="rect">
                <a:avLst/>
              </a:prstGeom>
            </p:spPr>
          </p:pic>
          <p:grpSp>
            <p:nvGrpSpPr>
              <p:cNvPr id="17" name="组合 16"/>
              <p:cNvGrpSpPr/>
              <p:nvPr/>
            </p:nvGrpSpPr>
            <p:grpSpPr>
              <a:xfrm>
                <a:off x="1148513" y="908317"/>
                <a:ext cx="4364522" cy="2992037"/>
                <a:chOff x="1148513" y="908317"/>
                <a:chExt cx="4364522" cy="2992037"/>
              </a:xfrm>
            </p:grpSpPr>
            <p:cxnSp>
              <p:nvCxnSpPr>
                <p:cNvPr id="11" name="直接箭头连接符 10"/>
                <p:cNvCxnSpPr/>
                <p:nvPr/>
              </p:nvCxnSpPr>
              <p:spPr>
                <a:xfrm>
                  <a:off x="1148513" y="3891476"/>
                  <a:ext cx="4364522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直接箭头连接符 12"/>
                <p:cNvCxnSpPr/>
                <p:nvPr/>
              </p:nvCxnSpPr>
              <p:spPr>
                <a:xfrm flipV="1">
                  <a:off x="1148513" y="908317"/>
                  <a:ext cx="0" cy="2992037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" name="文本框 17"/>
            <p:cNvSpPr txBox="1"/>
            <p:nvPr/>
          </p:nvSpPr>
          <p:spPr>
            <a:xfrm>
              <a:off x="2030250" y="1281545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030249" y="2665655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Vector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426350" y="1281544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TLR1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3479324" y="2665655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TLR1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4853577" y="1281544"/>
              <a:ext cx="6190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TLR4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4909528" y="2662729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TLR4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文本框 25"/>
          <p:cNvSpPr txBox="1"/>
          <p:nvPr/>
        </p:nvSpPr>
        <p:spPr>
          <a:xfrm rot="16200000">
            <a:off x="1151494" y="2692307"/>
            <a:ext cx="1336584" cy="539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FSC-W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6237028" y="6571335"/>
            <a:ext cx="2150042" cy="539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RP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PE-A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4C56C26-68EC-E753-66A2-CB7D528C0CD9}"/>
              </a:ext>
            </a:extLst>
          </p:cNvPr>
          <p:cNvSpPr txBox="1"/>
          <p:nvPr/>
        </p:nvSpPr>
        <p:spPr>
          <a:xfrm>
            <a:off x="0" y="-40943"/>
            <a:ext cx="7468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epresentative dot plots and gating of </a:t>
            </a:r>
            <a:r>
              <a:rPr lang="en-US" altLang="zh-CN" i="1" dirty="0" err="1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NRP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engaged cells for Fig 4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Office PowerPoint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朝阳 王</dc:creator>
  <cp:lastModifiedBy>朝阳 王</cp:lastModifiedBy>
  <cp:revision>1</cp:revision>
  <dcterms:created xsi:type="dcterms:W3CDTF">2023-12-12T16:20:46Z</dcterms:created>
  <dcterms:modified xsi:type="dcterms:W3CDTF">2023-12-12T16:22:41Z</dcterms:modified>
</cp:coreProperties>
</file>